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732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75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678" y="108"/>
      </p:cViewPr>
      <p:guideLst>
        <p:guide orient="horz" pos="275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6D084C2-2283-490F-ADF1-BA6D462F4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C8DEE176-4B0D-451A-8F58-CAAD3BE6324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372A5F9-8831-4848-8F92-750D273CEE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5F0906B-3CC1-496A-9C4D-761D91E6CF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7F8C589-6840-4CAA-87B9-A3BE8C7D28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727920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6B4A42F-C51B-45A8-BDF1-11AFF90326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C23B2774-70D6-426F-9BCE-CCFA458D0D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0EC5137C-92DC-4E93-B884-A426F66964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5CC8FBF-B0A0-4101-BD8C-768FED8727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D9E64543-AF48-469D-AA26-278E7FF435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80749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4AD43116-7CD9-4C2C-B83A-6C20A19475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4C7DE540-29D9-4E7E-86AB-6D8E77902E6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10739E1-16A2-4809-A0B0-71B110AC1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2981CCC1-1EEC-4DC6-A9E4-C0385D0F69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A164538-A218-4978-805F-45F2CD5792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417019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4F880AF-E4A0-4B25-9214-8C8AAADDF1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C247C81-D600-400F-954F-A9CA48EE5B1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A2A0433-F899-40E5-AA4D-AC1C1B04CE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13CB128-41C7-4DCF-B43D-A180E6699A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F415E362-7A4D-4441-B1DE-FDCDBA320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537552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888787A-4774-424E-99F2-195CB20D68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89A0BA83-AEE6-424B-98AD-0CAF70BC71F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86BE076C-A95B-4903-8318-8F4D44B9D9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ABE9BA8E-66ED-4E55-B18F-AF6CC2EE5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DBC54D9-304A-48E2-B71A-EB0315673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9116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42B3098-D0ED-4588-9D1F-2ACD6C9695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A8055642-6659-446D-B5C2-80C8AA7FC06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5280F5A6-7683-444E-B436-8789B5DFED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7F29F37-E780-4171-AD12-488EE477B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1FBBBCC9-0C2D-4E65-AB40-390665DB27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186CDAB-00FE-426F-9E3D-24C40C225B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75541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42E55BD-FBFE-4BEF-81CB-F56E97535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52E07B8D-73B0-4A7F-B425-0161240782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DAA32DA-90E8-4349-888C-363F944306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41940047-5909-46D8-8663-12254565FB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7488579B-1D6C-4427-9055-D04BB00A0E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1323924-D4D9-4E40-B33F-04AE9B5AE1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EF02E358-B211-47AE-AB64-42141B8A2D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64AA8E6F-637B-45C5-B165-3C033BACB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92470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F2E03FD-540D-4312-84D8-796B5F8D8E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3CDAEED-BE13-41BB-BA80-7CB2AE629D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97BBB50F-53C4-492F-96D0-FF90830865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80A75D38-E45D-49A6-8E4A-79F801F12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86592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6C8B9CE5-6FF7-45AD-A201-116BCCE9AD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06A07D18-B783-400D-AB7B-A11C8CB6F6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1A7209C2-A74F-4D90-A91A-7DEE2BE1BA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5333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2BAE345-6E74-49E5-A7EA-9370EDA2EA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0515C8BF-DBAD-4C46-9F1D-5E81DECBAB1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28F3837D-4B2D-4A3D-8E9F-D2E981CE05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F4ADAD14-F80B-4DF6-93D8-2B6C4A353C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3C66F92-FD11-4AE1-B517-D22A197DC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833146AA-E7C7-4B50-8BAA-A060084949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51188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4F245FF-90DD-43F4-A799-5492588479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9E47834A-3C05-40BB-B43A-7B9FBACC31C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14D7479-31E9-4530-B553-4F9096AC68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33EDF0D4-3CFD-4B20-B47B-6133B730FB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4B3B1E1-F3AE-4EC2-B728-5DD48F06FB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329D0E8-5611-435F-AEBB-6B5FFDBA48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5709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43D28E1-5C69-4208-9A1F-2929DACCEB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0750E4EA-1ACE-453F-8C24-80821BE2EA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EB60041A-1460-4A42-A7A4-80D30420833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66A65A-505A-431E-8BDA-9E9BD25C6F9C}" type="datetimeFigureOut">
              <a:rPr lang="ko-KR" altLang="en-US" smtClean="0"/>
              <a:t>2022-01-19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1F5C55C6-C9EF-4D35-B68C-D77FD461389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5AE422A-81FF-4885-B4F6-AC6E785DCBE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93ACC-841A-428A-BFCA-2BBA3BD0E59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92999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>
            <a:extLst>
              <a:ext uri="{FF2B5EF4-FFF2-40B4-BE49-F238E27FC236}">
                <a16:creationId xmlns:a16="http://schemas.microsoft.com/office/drawing/2014/main" id="{82070B10-2028-4166-9871-DDFAFA100F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09041" y="642660"/>
            <a:ext cx="7544451" cy="3388360"/>
          </a:xfrm>
          <a:prstGeom prst="rect">
            <a:avLst/>
          </a:prstGeom>
        </p:spPr>
      </p:pic>
      <p:sp>
        <p:nvSpPr>
          <p:cNvPr id="3" name="직사각형 2">
            <a:extLst>
              <a:ext uri="{FF2B5EF4-FFF2-40B4-BE49-F238E27FC236}">
                <a16:creationId xmlns:a16="http://schemas.microsoft.com/office/drawing/2014/main" id="{5F88C236-065E-4D34-941D-D13CA75717D1}"/>
              </a:ext>
            </a:extLst>
          </p:cNvPr>
          <p:cNvSpPr/>
          <p:nvPr/>
        </p:nvSpPr>
        <p:spPr>
          <a:xfrm>
            <a:off x="901700" y="4570966"/>
            <a:ext cx="10819245" cy="158985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algn="just">
              <a:lnSpc>
                <a:spcPct val="150000"/>
              </a:lnSpc>
            </a:pPr>
            <a:r>
              <a:rPr lang="en-US" altLang="ko-KR" sz="1100" b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igure S3.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PCR amplification of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scherichia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trains specific triplex primer set (O1) with our lab isolated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 The laboratory isolated 23 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were tested with the triplex marker. PCR band ‘M’ indicates DNA 100 bp marker. The gel lane numbers are as follows: lanes from 1-25: lane no.1= positive lane of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157:H7 (ATTC-95150), lane no.13  for a positive lane of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KVCC-BA1800069), and lane no.14 for a positive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145:H28 (KVCC-BA1800090). Lane No. 2-8 =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scherichia 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O157:H7 (amplicon size 401 bp) was detected from the sample of wild boar (lane 2-4); water dear (lane 5-8),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(amplicon length, 337 bp) positive lane No. 9-11= water dear; lane</a:t>
            </a:r>
            <a:r>
              <a:rPr lang="ko-KR" altLang="en-US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2 was unknown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strain;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O145:H28 (amplicon length, 232 bp) positive lane no. </a:t>
            </a:r>
            <a:r>
              <a:rPr lang="en-US" altLang="ko-KR" sz="110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15-19= 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flying squirrel, Unknown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 strains lane No. 20-22=leopard cat; and lane no. 23-25. = roe dear </a:t>
            </a:r>
            <a:r>
              <a:rPr lang="en-US" altLang="ko-KR" sz="1100" i="1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E. coli</a:t>
            </a:r>
            <a:r>
              <a:rPr lang="en-US" altLang="ko-KR" sz="1100" dirty="0">
                <a:solidFill>
                  <a:prstClr val="black"/>
                </a:solidFill>
                <a:latin typeface="Palatino Linotype" panose="02040502050505030304" pitchFamily="18" charset="0"/>
                <a:ea typeface="Malgun Gothic" panose="020B0503020000020004" pitchFamily="34" charset="-127"/>
                <a:cs typeface="Times New Roman" panose="02020603050405020304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5085178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29</TotalTime>
  <Words>220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맑은 고딕</vt:lpstr>
      <vt:lpstr>Arial</vt:lpstr>
      <vt:lpstr>Palatino Linotype</vt:lpstr>
      <vt:lpstr>Times New Roman</vt:lpstr>
      <vt:lpstr>Office 테마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Md Mafizur Rahman</dc:creator>
  <cp:lastModifiedBy>MDPI</cp:lastModifiedBy>
  <cp:revision>32</cp:revision>
  <dcterms:created xsi:type="dcterms:W3CDTF">2021-12-27T03:26:09Z</dcterms:created>
  <dcterms:modified xsi:type="dcterms:W3CDTF">2022-01-19T09:59:10Z</dcterms:modified>
</cp:coreProperties>
</file>